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88D372-D9F3-426C-9660-66DDDFECE0C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BBF113-0EF5-4347-98B5-B3EE34BF45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D0A119-C26A-4E34-AA9D-36E7A22997D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B04D3A-0EBE-449F-90E8-2FB964957B7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BCB059-F4D4-432D-9117-A86796B8C9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76EB0C-AD92-4111-8715-6DE4FC252F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BFB682-5D07-4F85-B478-8E772B13BA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E00863-0D6F-4ABC-9812-A33CB9D4E9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AA9B40-EED6-48AD-9ECC-A8599E132D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F452AB-2620-404E-B753-4DB4265B7D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0D46DA-A276-4F41-8216-09605694FB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B9BC92-EE8B-4C41-A6FB-3DC929C2C9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B3006BF-1379-4813-B035-33175A5AD7F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67"/>
          <p:cNvGrpSpPr/>
          <p:nvPr/>
        </p:nvGrpSpPr>
        <p:grpSpPr>
          <a:xfrm>
            <a:off x="231480" y="433440"/>
            <a:ext cx="8579520" cy="1825920"/>
            <a:chOff x="231480" y="433440"/>
            <a:chExt cx="8579520" cy="1825920"/>
          </a:xfrm>
        </p:grpSpPr>
        <p:sp>
          <p:nvSpPr>
            <p:cNvPr id="42" name="Line 37"/>
            <p:cNvSpPr/>
            <p:nvPr/>
          </p:nvSpPr>
          <p:spPr>
            <a:xfrm>
              <a:off x="556560" y="1155600"/>
              <a:ext cx="78796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38"/>
            <p:cNvSpPr/>
            <p:nvPr/>
          </p:nvSpPr>
          <p:spPr>
            <a:xfrm>
              <a:off x="3275640" y="1022040"/>
              <a:ext cx="304200" cy="19728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39"/>
            <p:cNvSpPr/>
            <p:nvPr/>
          </p:nvSpPr>
          <p:spPr>
            <a:xfrm>
              <a:off x="6317640" y="1051920"/>
              <a:ext cx="81720" cy="19728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40"/>
            <p:cNvSpPr/>
            <p:nvPr/>
          </p:nvSpPr>
          <p:spPr>
            <a:xfrm>
              <a:off x="231480" y="738360"/>
              <a:ext cx="744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-100k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41"/>
            <p:cNvSpPr/>
            <p:nvPr/>
          </p:nvSpPr>
          <p:spPr>
            <a:xfrm>
              <a:off x="8075520" y="738360"/>
              <a:ext cx="735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00 k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AutoShape 42"/>
            <p:cNvSpPr/>
            <p:nvPr/>
          </p:nvSpPr>
          <p:spPr>
            <a:xfrm flipH="1" rot="5400000">
              <a:off x="1291680" y="458640"/>
              <a:ext cx="82080" cy="1557720"/>
            </a:xfrm>
            <a:custGeom>
              <a:avLst/>
              <a:gdLst>
                <a:gd name="textAreaLeft" fmla="*/ 52920 w 82080"/>
                <a:gd name="textAreaRight" fmla="*/ 82800 w 82080"/>
                <a:gd name="textAreaTop" fmla="*/ 83520 h 1557720"/>
                <a:gd name="textAreaBottom" fmla="*/ 1474200 h 155772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1857"/>
                    <a:pt x="10800" y="3713"/>
                  </a:cubicBezTo>
                  <a:lnTo>
                    <a:pt x="10800" y="7785"/>
                  </a:lnTo>
                  <a:cubicBezTo>
                    <a:pt x="10800" y="9642"/>
                    <a:pt x="5400" y="11498"/>
                    <a:pt x="0" y="11498"/>
                  </a:cubicBezTo>
                  <a:cubicBezTo>
                    <a:pt x="5400" y="11498"/>
                    <a:pt x="10800" y="13355"/>
                    <a:pt x="10800" y="15211"/>
                  </a:cubicBezTo>
                  <a:lnTo>
                    <a:pt x="10800" y="17887"/>
                  </a:lnTo>
                  <a:cubicBezTo>
                    <a:pt x="10800" y="19744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47"/>
            <p:cNvSpPr/>
            <p:nvPr/>
          </p:nvSpPr>
          <p:spPr>
            <a:xfrm>
              <a:off x="3092760" y="1271880"/>
              <a:ext cx="717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5’TS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48"/>
            <p:cNvSpPr/>
            <p:nvPr/>
          </p:nvSpPr>
          <p:spPr>
            <a:xfrm>
              <a:off x="6040440" y="433440"/>
              <a:ext cx="67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3’TS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AutoShape 49"/>
            <p:cNvSpPr/>
            <p:nvPr/>
          </p:nvSpPr>
          <p:spPr>
            <a:xfrm rot="16200000">
              <a:off x="3418200" y="1134000"/>
              <a:ext cx="46080" cy="280080"/>
            </a:xfrm>
            <a:custGeom>
              <a:avLst/>
              <a:gdLst>
                <a:gd name="textAreaLeft" fmla="*/ 29520 w 46080"/>
                <a:gd name="textAreaRight" fmla="*/ 46440 w 46080"/>
                <a:gd name="textAreaTop" fmla="*/ 3960 h 280080"/>
                <a:gd name="textAreaBottom" fmla="*/ 276120 h 28008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499"/>
                    <a:pt x="10800" y="998"/>
                  </a:cubicBezTo>
                  <a:lnTo>
                    <a:pt x="10800" y="10500"/>
                  </a:lnTo>
                  <a:cubicBezTo>
                    <a:pt x="10800" y="10999"/>
                    <a:pt x="5400" y="11498"/>
                    <a:pt x="0" y="11498"/>
                  </a:cubicBezTo>
                  <a:cubicBezTo>
                    <a:pt x="5400" y="11498"/>
                    <a:pt x="10800" y="11997"/>
                    <a:pt x="10800" y="12496"/>
                  </a:cubicBezTo>
                  <a:lnTo>
                    <a:pt x="10800" y="20602"/>
                  </a:lnTo>
                  <a:cubicBezTo>
                    <a:pt x="10800" y="21101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51"/>
            <p:cNvSpPr/>
            <p:nvPr/>
          </p:nvSpPr>
          <p:spPr>
            <a:xfrm>
              <a:off x="3352320" y="1739160"/>
              <a:ext cx="11782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WithinGen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Cor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52"/>
            <p:cNvSpPr/>
            <p:nvPr/>
          </p:nvSpPr>
          <p:spPr>
            <a:xfrm>
              <a:off x="882720" y="1303560"/>
              <a:ext cx="916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5’ Distal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53"/>
            <p:cNvSpPr/>
            <p:nvPr/>
          </p:nvSpPr>
          <p:spPr>
            <a:xfrm>
              <a:off x="7571160" y="1303560"/>
              <a:ext cx="887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3’ Dista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56"/>
            <p:cNvSpPr/>
            <p:nvPr/>
          </p:nvSpPr>
          <p:spPr>
            <a:xfrm>
              <a:off x="2112840" y="958320"/>
              <a:ext cx="0" cy="196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57"/>
            <p:cNvSpPr/>
            <p:nvPr/>
          </p:nvSpPr>
          <p:spPr>
            <a:xfrm>
              <a:off x="7543440" y="958320"/>
              <a:ext cx="0" cy="196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58"/>
            <p:cNvSpPr/>
            <p:nvPr/>
          </p:nvSpPr>
          <p:spPr>
            <a:xfrm>
              <a:off x="1706760" y="738360"/>
              <a:ext cx="645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-10k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59"/>
            <p:cNvSpPr/>
            <p:nvPr/>
          </p:nvSpPr>
          <p:spPr>
            <a:xfrm>
              <a:off x="7254720" y="738360"/>
              <a:ext cx="58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0k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AutoShape 60"/>
            <p:cNvSpPr/>
            <p:nvPr/>
          </p:nvSpPr>
          <p:spPr>
            <a:xfrm flipH="1" rot="5400000">
              <a:off x="2457360" y="876960"/>
              <a:ext cx="49320" cy="738720"/>
            </a:xfrm>
            <a:custGeom>
              <a:avLst/>
              <a:gdLst>
                <a:gd name="textAreaLeft" fmla="*/ 31320 w 49320"/>
                <a:gd name="textAreaRight" fmla="*/ 49320 w 49320"/>
                <a:gd name="textAreaTop" fmla="*/ 19080 h 738720"/>
                <a:gd name="textAreaBottom" fmla="*/ 719640 h 73872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698"/>
                  </a:lnTo>
                  <a:cubicBezTo>
                    <a:pt x="10800" y="10598"/>
                    <a:pt x="5400" y="11498"/>
                    <a:pt x="0" y="11498"/>
                  </a:cubicBezTo>
                  <a:cubicBezTo>
                    <a:pt x="5400" y="11498"/>
                    <a:pt x="10800" y="12398"/>
                    <a:pt x="10800" y="13298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61"/>
            <p:cNvSpPr/>
            <p:nvPr/>
          </p:nvSpPr>
          <p:spPr>
            <a:xfrm>
              <a:off x="1893960" y="1303560"/>
              <a:ext cx="1229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5’ Proximal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AutoShape 62"/>
            <p:cNvSpPr/>
            <p:nvPr/>
          </p:nvSpPr>
          <p:spPr>
            <a:xfrm flipH="1" rot="5400000">
              <a:off x="7126200" y="909360"/>
              <a:ext cx="48960" cy="738720"/>
            </a:xfrm>
            <a:custGeom>
              <a:avLst/>
              <a:gdLst>
                <a:gd name="textAreaLeft" fmla="*/ 31320 w 48960"/>
                <a:gd name="textAreaRight" fmla="*/ 49320 w 48960"/>
                <a:gd name="textAreaTop" fmla="*/ 19080 h 738720"/>
                <a:gd name="textAreaBottom" fmla="*/ 719640 h 73872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698"/>
                  </a:lnTo>
                  <a:cubicBezTo>
                    <a:pt x="10800" y="10598"/>
                    <a:pt x="5400" y="11498"/>
                    <a:pt x="0" y="11498"/>
                  </a:cubicBezTo>
                  <a:cubicBezTo>
                    <a:pt x="5400" y="11498"/>
                    <a:pt x="10800" y="12398"/>
                    <a:pt x="10800" y="13298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AutoShape 64"/>
            <p:cNvSpPr/>
            <p:nvPr/>
          </p:nvSpPr>
          <p:spPr>
            <a:xfrm rot="16200000">
              <a:off x="6555960" y="1075680"/>
              <a:ext cx="46080" cy="406440"/>
            </a:xfrm>
            <a:custGeom>
              <a:avLst/>
              <a:gdLst>
                <a:gd name="textAreaLeft" fmla="*/ 29520 w 46080"/>
                <a:gd name="textAreaRight" fmla="*/ 46440 w 46080"/>
                <a:gd name="textAreaTop" fmla="*/ 3960 h 406440"/>
                <a:gd name="textAreaBottom" fmla="*/ 402480 h 40644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344"/>
                    <a:pt x="10800" y="688"/>
                  </a:cubicBezTo>
                  <a:lnTo>
                    <a:pt x="10800" y="10810"/>
                  </a:lnTo>
                  <a:cubicBezTo>
                    <a:pt x="10800" y="11154"/>
                    <a:pt x="5400" y="11498"/>
                    <a:pt x="0" y="11498"/>
                  </a:cubicBezTo>
                  <a:cubicBezTo>
                    <a:pt x="5400" y="11498"/>
                    <a:pt x="10800" y="11842"/>
                    <a:pt x="10800" y="12186"/>
                  </a:cubicBezTo>
                  <a:lnTo>
                    <a:pt x="10800" y="20912"/>
                  </a:lnTo>
                  <a:cubicBezTo>
                    <a:pt x="10800" y="21256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65"/>
            <p:cNvSpPr/>
            <p:nvPr/>
          </p:nvSpPr>
          <p:spPr>
            <a:xfrm>
              <a:off x="6603120" y="1804680"/>
              <a:ext cx="1169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3’ Proximal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AutoShape 66"/>
            <p:cNvSpPr/>
            <p:nvPr/>
          </p:nvSpPr>
          <p:spPr>
            <a:xfrm flipH="1" rot="5400000">
              <a:off x="7965720" y="834120"/>
              <a:ext cx="46080" cy="892440"/>
            </a:xfrm>
            <a:custGeom>
              <a:avLst/>
              <a:gdLst>
                <a:gd name="textAreaLeft" fmla="*/ 29880 w 46080"/>
                <a:gd name="textAreaRight" fmla="*/ 46800 w 46080"/>
                <a:gd name="textAreaTop" fmla="*/ 46800 h 892440"/>
                <a:gd name="textAreaBottom" fmla="*/ 845640 h 89244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1823"/>
                    <a:pt x="10800" y="3645"/>
                  </a:cubicBezTo>
                  <a:lnTo>
                    <a:pt x="10800" y="7853"/>
                  </a:lnTo>
                  <a:cubicBezTo>
                    <a:pt x="10800" y="9676"/>
                    <a:pt x="5400" y="11498"/>
                    <a:pt x="0" y="11498"/>
                  </a:cubicBezTo>
                  <a:cubicBezTo>
                    <a:pt x="5400" y="11498"/>
                    <a:pt x="10800" y="13321"/>
                    <a:pt x="10800" y="15143"/>
                  </a:cubicBezTo>
                  <a:lnTo>
                    <a:pt x="10800" y="17955"/>
                  </a:lnTo>
                  <a:cubicBezTo>
                    <a:pt x="10800" y="19778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4" name="Text Box 72"/>
          <p:cNvSpPr/>
          <p:nvPr/>
        </p:nvSpPr>
        <p:spPr>
          <a:xfrm>
            <a:off x="154080" y="15228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73"/>
          <p:cNvSpPr/>
          <p:nvPr/>
        </p:nvSpPr>
        <p:spPr>
          <a:xfrm>
            <a:off x="154080" y="24829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AutoShape 60"/>
          <p:cNvSpPr/>
          <p:nvPr/>
        </p:nvSpPr>
        <p:spPr>
          <a:xfrm flipH="1" rot="5400000">
            <a:off x="3048120" y="1041840"/>
            <a:ext cx="75960" cy="382680"/>
          </a:xfrm>
          <a:custGeom>
            <a:avLst/>
            <a:gdLst>
              <a:gd name="textAreaLeft" fmla="*/ 48600 w 75960"/>
              <a:gd name="textAreaRight" fmla="*/ 76320 w 75960"/>
              <a:gd name="textAreaTop" fmla="*/ 17640 h 382680"/>
              <a:gd name="textAreaBottom" fmla="*/ 365040 h 3826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616"/>
                  <a:pt x="10800" y="3231"/>
                </a:cubicBezTo>
                <a:lnTo>
                  <a:pt x="10800" y="8267"/>
                </a:lnTo>
                <a:cubicBezTo>
                  <a:pt x="10800" y="9883"/>
                  <a:pt x="5400" y="11498"/>
                  <a:pt x="0" y="11498"/>
                </a:cubicBezTo>
                <a:cubicBezTo>
                  <a:pt x="5400" y="11498"/>
                  <a:pt x="10800" y="13114"/>
                  <a:pt x="10800" y="14729"/>
                </a:cubicBezTo>
                <a:lnTo>
                  <a:pt x="10800" y="18369"/>
                </a:lnTo>
                <a:cubicBezTo>
                  <a:pt x="10800" y="19985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61"/>
          <p:cNvSpPr/>
          <p:nvPr/>
        </p:nvSpPr>
        <p:spPr>
          <a:xfrm>
            <a:off x="2666880" y="1805040"/>
            <a:ext cx="838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5’ Cor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45"/>
          <p:cNvSpPr/>
          <p:nvPr/>
        </p:nvSpPr>
        <p:spPr>
          <a:xfrm>
            <a:off x="3048120" y="1271520"/>
            <a:ext cx="0" cy="609840"/>
          </a:xfrm>
          <a:prstGeom prst="line">
            <a:avLst/>
          </a:prstGeom>
          <a:ln cap="rnd" w="9360">
            <a:solidFill>
              <a:srgbClr val="80808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56"/>
          <p:cNvSpPr/>
          <p:nvPr/>
        </p:nvSpPr>
        <p:spPr>
          <a:xfrm>
            <a:off x="2895480" y="966960"/>
            <a:ext cx="0" cy="196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58"/>
          <p:cNvSpPr/>
          <p:nvPr/>
        </p:nvSpPr>
        <p:spPr>
          <a:xfrm>
            <a:off x="2603160" y="738360"/>
            <a:ext cx="54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-2k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56"/>
          <p:cNvSpPr/>
          <p:nvPr/>
        </p:nvSpPr>
        <p:spPr>
          <a:xfrm>
            <a:off x="3276720" y="966960"/>
            <a:ext cx="0" cy="196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58"/>
          <p:cNvSpPr/>
          <p:nvPr/>
        </p:nvSpPr>
        <p:spPr>
          <a:xfrm>
            <a:off x="3091320" y="738360"/>
            <a:ext cx="54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-1k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56"/>
          <p:cNvSpPr/>
          <p:nvPr/>
        </p:nvSpPr>
        <p:spPr>
          <a:xfrm>
            <a:off x="3581280" y="914400"/>
            <a:ext cx="0" cy="249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58"/>
          <p:cNvSpPr/>
          <p:nvPr/>
        </p:nvSpPr>
        <p:spPr>
          <a:xfrm>
            <a:off x="3472920" y="685800"/>
            <a:ext cx="487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k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AutoShape 60"/>
          <p:cNvSpPr/>
          <p:nvPr/>
        </p:nvSpPr>
        <p:spPr>
          <a:xfrm flipH="1" rot="5400000">
            <a:off x="3923280" y="928440"/>
            <a:ext cx="76320" cy="762120"/>
          </a:xfrm>
          <a:custGeom>
            <a:avLst/>
            <a:gdLst>
              <a:gd name="textAreaLeft" fmla="*/ 48960 w 76320"/>
              <a:gd name="textAreaRight" fmla="*/ 76320 w 76320"/>
              <a:gd name="textAreaTop" fmla="*/ 17640 h 762120"/>
              <a:gd name="textAreaBottom" fmla="*/ 744480 h 7621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811"/>
                  <a:pt x="10800" y="1622"/>
                </a:cubicBezTo>
                <a:lnTo>
                  <a:pt x="10800" y="9876"/>
                </a:lnTo>
                <a:cubicBezTo>
                  <a:pt x="10800" y="10687"/>
                  <a:pt x="5400" y="11498"/>
                  <a:pt x="0" y="11498"/>
                </a:cubicBezTo>
                <a:cubicBezTo>
                  <a:pt x="5400" y="11498"/>
                  <a:pt x="10800" y="12309"/>
                  <a:pt x="10800" y="13120"/>
                </a:cubicBezTo>
                <a:lnTo>
                  <a:pt x="10800" y="19978"/>
                </a:lnTo>
                <a:cubicBezTo>
                  <a:pt x="10800" y="20789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56"/>
          <p:cNvSpPr/>
          <p:nvPr/>
        </p:nvSpPr>
        <p:spPr>
          <a:xfrm>
            <a:off x="4343400" y="966960"/>
            <a:ext cx="0" cy="196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56"/>
          <p:cNvSpPr/>
          <p:nvPr/>
        </p:nvSpPr>
        <p:spPr>
          <a:xfrm>
            <a:off x="533520" y="966960"/>
            <a:ext cx="0" cy="196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58"/>
          <p:cNvSpPr/>
          <p:nvPr/>
        </p:nvSpPr>
        <p:spPr>
          <a:xfrm>
            <a:off x="4081680" y="685800"/>
            <a:ext cx="487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k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45"/>
          <p:cNvSpPr/>
          <p:nvPr/>
        </p:nvSpPr>
        <p:spPr>
          <a:xfrm>
            <a:off x="3962520" y="1347840"/>
            <a:ext cx="0" cy="457200"/>
          </a:xfrm>
          <a:prstGeom prst="line">
            <a:avLst/>
          </a:prstGeom>
          <a:ln cap="rnd" w="9360">
            <a:solidFill>
              <a:srgbClr val="80808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58"/>
          <p:cNvSpPr/>
          <p:nvPr/>
        </p:nvSpPr>
        <p:spPr>
          <a:xfrm>
            <a:off x="4821120" y="738360"/>
            <a:ext cx="58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0k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56"/>
          <p:cNvSpPr/>
          <p:nvPr/>
        </p:nvSpPr>
        <p:spPr>
          <a:xfrm>
            <a:off x="8458200" y="966960"/>
            <a:ext cx="0" cy="196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56"/>
          <p:cNvSpPr/>
          <p:nvPr/>
        </p:nvSpPr>
        <p:spPr>
          <a:xfrm>
            <a:off x="6800760" y="969840"/>
            <a:ext cx="0" cy="196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58"/>
          <p:cNvSpPr/>
          <p:nvPr/>
        </p:nvSpPr>
        <p:spPr>
          <a:xfrm>
            <a:off x="6479640" y="738360"/>
            <a:ext cx="487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k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45"/>
          <p:cNvSpPr/>
          <p:nvPr/>
        </p:nvSpPr>
        <p:spPr>
          <a:xfrm>
            <a:off x="7162920" y="1295280"/>
            <a:ext cx="0" cy="586080"/>
          </a:xfrm>
          <a:prstGeom prst="line">
            <a:avLst/>
          </a:prstGeom>
          <a:ln cap="rnd" w="9360">
            <a:solidFill>
              <a:srgbClr val="80808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AutoShape 60"/>
          <p:cNvSpPr/>
          <p:nvPr/>
        </p:nvSpPr>
        <p:spPr>
          <a:xfrm flipH="1" rot="5400000">
            <a:off x="4710960" y="926640"/>
            <a:ext cx="49320" cy="738360"/>
          </a:xfrm>
          <a:custGeom>
            <a:avLst/>
            <a:gdLst>
              <a:gd name="textAreaLeft" fmla="*/ 31320 w 49320"/>
              <a:gd name="textAreaRight" fmla="*/ 49320 w 49320"/>
              <a:gd name="textAreaTop" fmla="*/ 11520 h 738360"/>
              <a:gd name="textAreaBottom" fmla="*/ 726840 h 7383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541"/>
                  <a:pt x="10800" y="1081"/>
                </a:cubicBezTo>
                <a:lnTo>
                  <a:pt x="10800" y="10417"/>
                </a:lnTo>
                <a:cubicBezTo>
                  <a:pt x="10800" y="10958"/>
                  <a:pt x="5400" y="11498"/>
                  <a:pt x="0" y="11498"/>
                </a:cubicBezTo>
                <a:cubicBezTo>
                  <a:pt x="5400" y="11498"/>
                  <a:pt x="10800" y="12039"/>
                  <a:pt x="10800" y="12579"/>
                </a:cubicBezTo>
                <a:lnTo>
                  <a:pt x="10800" y="20519"/>
                </a:lnTo>
                <a:cubicBezTo>
                  <a:pt x="10800" y="2106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56"/>
          <p:cNvSpPr/>
          <p:nvPr/>
        </p:nvSpPr>
        <p:spPr>
          <a:xfrm>
            <a:off x="5087880" y="966960"/>
            <a:ext cx="0" cy="196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51"/>
          <p:cNvSpPr/>
          <p:nvPr/>
        </p:nvSpPr>
        <p:spPr>
          <a:xfrm>
            <a:off x="4156200" y="1357200"/>
            <a:ext cx="11779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WithinGen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roxim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AutoShape 42"/>
          <p:cNvSpPr/>
          <p:nvPr/>
        </p:nvSpPr>
        <p:spPr>
          <a:xfrm flipH="1" rot="5400000">
            <a:off x="5676840" y="699840"/>
            <a:ext cx="76320" cy="1218960"/>
          </a:xfrm>
          <a:custGeom>
            <a:avLst/>
            <a:gdLst>
              <a:gd name="textAreaLeft" fmla="*/ 48960 w 76320"/>
              <a:gd name="textAreaRight" fmla="*/ 76320 w 76320"/>
              <a:gd name="textAreaTop" fmla="*/ 46440 h 1218960"/>
              <a:gd name="textAreaBottom" fmla="*/ 1172520 h 12189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322"/>
                  <a:pt x="10800" y="2643"/>
                </a:cubicBezTo>
                <a:lnTo>
                  <a:pt x="10800" y="8855"/>
                </a:lnTo>
                <a:cubicBezTo>
                  <a:pt x="10800" y="10177"/>
                  <a:pt x="5400" y="11498"/>
                  <a:pt x="0" y="11498"/>
                </a:cubicBezTo>
                <a:cubicBezTo>
                  <a:pt x="5400" y="11498"/>
                  <a:pt x="10800" y="12820"/>
                  <a:pt x="10800" y="14141"/>
                </a:cubicBezTo>
                <a:lnTo>
                  <a:pt x="10800" y="18957"/>
                </a:lnTo>
                <a:cubicBezTo>
                  <a:pt x="10800" y="20279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56"/>
          <p:cNvSpPr/>
          <p:nvPr/>
        </p:nvSpPr>
        <p:spPr>
          <a:xfrm>
            <a:off x="6324480" y="662040"/>
            <a:ext cx="0" cy="501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51"/>
          <p:cNvSpPr/>
          <p:nvPr/>
        </p:nvSpPr>
        <p:spPr>
          <a:xfrm>
            <a:off x="5070600" y="1728720"/>
            <a:ext cx="11779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WithinGen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Dist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45"/>
          <p:cNvSpPr/>
          <p:nvPr/>
        </p:nvSpPr>
        <p:spPr>
          <a:xfrm>
            <a:off x="5715000" y="1347840"/>
            <a:ext cx="0" cy="457200"/>
          </a:xfrm>
          <a:prstGeom prst="line">
            <a:avLst/>
          </a:prstGeom>
          <a:ln cap="rnd" w="9360">
            <a:solidFill>
              <a:srgbClr val="80808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53"/>
          <p:cNvSpPr/>
          <p:nvPr/>
        </p:nvSpPr>
        <p:spPr>
          <a:xfrm>
            <a:off x="6172200" y="1271520"/>
            <a:ext cx="88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3’ Cor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AutoShape 42"/>
          <p:cNvSpPr/>
          <p:nvPr/>
        </p:nvSpPr>
        <p:spPr>
          <a:xfrm flipH="1" rot="5400000">
            <a:off x="4723560" y="1295280"/>
            <a:ext cx="76320" cy="2057400"/>
          </a:xfrm>
          <a:custGeom>
            <a:avLst/>
            <a:gdLst>
              <a:gd name="textAreaLeft" fmla="*/ 48960 w 76320"/>
              <a:gd name="textAreaRight" fmla="*/ 76320 w 76320"/>
              <a:gd name="textAreaTop" fmla="*/ 46440 h 2057400"/>
              <a:gd name="textAreaBottom" fmla="*/ 2010960 h 20574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783"/>
                  <a:pt x="10800" y="1566"/>
                </a:cubicBezTo>
                <a:lnTo>
                  <a:pt x="10800" y="9932"/>
                </a:lnTo>
                <a:cubicBezTo>
                  <a:pt x="10800" y="10715"/>
                  <a:pt x="5400" y="11498"/>
                  <a:pt x="0" y="11498"/>
                </a:cubicBezTo>
                <a:cubicBezTo>
                  <a:pt x="5400" y="11498"/>
                  <a:pt x="10800" y="12281"/>
                  <a:pt x="10800" y="13064"/>
                </a:cubicBezTo>
                <a:lnTo>
                  <a:pt x="10800" y="20034"/>
                </a:lnTo>
                <a:cubicBezTo>
                  <a:pt x="10800" y="20817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51"/>
          <p:cNvSpPr/>
          <p:nvPr/>
        </p:nvSpPr>
        <p:spPr>
          <a:xfrm>
            <a:off x="3962520" y="2371680"/>
            <a:ext cx="1828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ntragenic Reg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AutoShape 42"/>
          <p:cNvSpPr/>
          <p:nvPr/>
        </p:nvSpPr>
        <p:spPr>
          <a:xfrm rot="5400000">
            <a:off x="3543120" y="-38160"/>
            <a:ext cx="152640" cy="1447920"/>
          </a:xfrm>
          <a:custGeom>
            <a:avLst/>
            <a:gdLst>
              <a:gd name="textAreaLeft" fmla="*/ 97560 w 152640"/>
              <a:gd name="textAreaRight" fmla="*/ 153000 w 152640"/>
              <a:gd name="textAreaTop" fmla="*/ 93240 h 1447920"/>
              <a:gd name="textAreaBottom" fmla="*/ 1354680 h 14479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2226"/>
                  <a:pt x="10800" y="4451"/>
                </a:cubicBezTo>
                <a:lnTo>
                  <a:pt x="10800" y="7047"/>
                </a:lnTo>
                <a:cubicBezTo>
                  <a:pt x="10800" y="9273"/>
                  <a:pt x="5400" y="11498"/>
                  <a:pt x="0" y="11498"/>
                </a:cubicBezTo>
                <a:cubicBezTo>
                  <a:pt x="5400" y="11498"/>
                  <a:pt x="10800" y="13724"/>
                  <a:pt x="10800" y="15949"/>
                </a:cubicBezTo>
                <a:lnTo>
                  <a:pt x="10800" y="17149"/>
                </a:lnTo>
                <a:cubicBezTo>
                  <a:pt x="10800" y="19375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51"/>
          <p:cNvSpPr/>
          <p:nvPr/>
        </p:nvSpPr>
        <p:spPr>
          <a:xfrm>
            <a:off x="2743200" y="304920"/>
            <a:ext cx="1676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romoter Reg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7" name="Picture 60" descr=""/>
          <p:cNvPicPr/>
          <p:nvPr/>
        </p:nvPicPr>
        <p:blipFill>
          <a:blip r:embed="rId1"/>
          <a:stretch/>
        </p:blipFill>
        <p:spPr>
          <a:xfrm>
            <a:off x="1143000" y="2666880"/>
            <a:ext cx="7207200" cy="3924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1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02T21:09:14Z</dcterms:created>
  <dc:creator>Victor</dc:creator>
  <dc:description/>
  <dc:language>en-US</dc:language>
  <cp:lastModifiedBy>Fei Gu</cp:lastModifiedBy>
  <dcterms:modified xsi:type="dcterms:W3CDTF">2010-12-11T04:16:25Z</dcterms:modified>
  <cp:revision>505</cp:revision>
  <dc:subject/>
  <dc:title>Slide 1</dc:title>
</cp:coreProperties>
</file>